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923E7-FB02-4969-B9B1-20F6DB60D8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DA4A7-3D9B-4816-A75B-16C83B028A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E9452C-72F0-4FFF-A35B-1AE35D1003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E66B3-7D3A-4A2E-8E20-720FB92362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219F1-46CE-49D0-9C6D-03FB59E4CF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A95F7-D9BE-4967-A6B2-21CFB91773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9DE0E-3CAE-4F4F-B863-8105C8019D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FC408-1C77-465F-A3EF-1F048799FD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B7AD5-710C-4128-ACD3-2C0CF16F3B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3E379-F01D-4A0B-8ACE-293D87FF72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1FD52-F80E-4A22-8BE4-FC3096C253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7CA84-E1A1-4428-92AB-BB21723854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064D91-A058-42CF-94EC-057A184A81C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865080" y="457200"/>
            <a:ext cx="8001000" cy="1927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6578" t="0" r="0" b="50013"/>
          <a:stretch/>
        </p:blipFill>
        <p:spPr>
          <a:xfrm>
            <a:off x="1206360" y="3660840"/>
            <a:ext cx="7709040" cy="1280880"/>
          </a:xfrm>
          <a:prstGeom prst="rect">
            <a:avLst/>
          </a:prstGeom>
          <a:ln w="0">
            <a:noFill/>
          </a:ln>
        </p:spPr>
      </p:pic>
      <p:sp>
        <p:nvSpPr>
          <p:cNvPr id="43" name="TextBox 1"/>
          <p:cNvSpPr/>
          <p:nvPr/>
        </p:nvSpPr>
        <p:spPr>
          <a:xfrm>
            <a:off x="228600" y="7632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19240" y="304812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7"/>
          <p:cNvSpPr/>
          <p:nvPr/>
        </p:nvSpPr>
        <p:spPr>
          <a:xfrm>
            <a:off x="1295280" y="2435400"/>
            <a:ext cx="757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IV-1 Transcript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7"/>
          <p:cNvSpPr/>
          <p:nvPr/>
        </p:nvSpPr>
        <p:spPr>
          <a:xfrm>
            <a:off x="190440" y="3936960"/>
            <a:ext cx="120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ccurrence Coun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3" descr=""/>
          <p:cNvPicPr/>
          <p:nvPr/>
        </p:nvPicPr>
        <p:blipFill>
          <a:blip r:embed="rId3"/>
          <a:srcRect l="6578" t="50013" r="0" b="0"/>
          <a:stretch/>
        </p:blipFill>
        <p:spPr>
          <a:xfrm>
            <a:off x="1206360" y="5272200"/>
            <a:ext cx="7709040" cy="1280880"/>
          </a:xfrm>
          <a:prstGeom prst="rect">
            <a:avLst/>
          </a:prstGeom>
          <a:ln w="0">
            <a:noFill/>
          </a:ln>
        </p:spPr>
      </p:pic>
      <p:sp>
        <p:nvSpPr>
          <p:cNvPr id="48" name="TextBox 17"/>
          <p:cNvSpPr/>
          <p:nvPr/>
        </p:nvSpPr>
        <p:spPr>
          <a:xfrm>
            <a:off x="190440" y="5595840"/>
            <a:ext cx="120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ccurrence Coun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7"/>
          <p:cNvSpPr/>
          <p:nvPr/>
        </p:nvSpPr>
        <p:spPr>
          <a:xfrm>
            <a:off x="1905120" y="4903920"/>
            <a:ext cx="701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mplicon Identity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7"/>
          <p:cNvSpPr/>
          <p:nvPr/>
        </p:nvSpPr>
        <p:spPr>
          <a:xfrm>
            <a:off x="1905120" y="6556320"/>
            <a:ext cx="701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mplicon Identity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7"/>
          <p:cNvSpPr/>
          <p:nvPr/>
        </p:nvSpPr>
        <p:spPr>
          <a:xfrm>
            <a:off x="684360" y="3354480"/>
            <a:ext cx="71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2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7"/>
          <p:cNvSpPr/>
          <p:nvPr/>
        </p:nvSpPr>
        <p:spPr>
          <a:xfrm>
            <a:off x="685800" y="5003640"/>
            <a:ext cx="71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26T01:10:32Z</dcterms:created>
  <dc:creator>Laith</dc:creator>
  <dc:description/>
  <dc:language>en-US</dc:language>
  <cp:lastModifiedBy>User</cp:lastModifiedBy>
  <cp:lastPrinted>2013-06-04T19:23:41Z</cp:lastPrinted>
  <dcterms:modified xsi:type="dcterms:W3CDTF">2014-10-31T19:06:11Z</dcterms:modified>
  <cp:revision>201</cp:revision>
  <dc:subject/>
  <dc:title>PowerPoint Presentation</dc:title>
</cp:coreProperties>
</file>